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62" r:id="rId4"/>
    <p:sldId id="263" r:id="rId5"/>
    <p:sldId id="259" r:id="rId6"/>
    <p:sldId id="264" r:id="rId7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F118DFD-6945-4FEF-9424-F8296607B62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CAEBE303-24A3-4241-94F8-C4F47285AD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08C6551-C3F1-47CE-AE4A-B34D2FD07C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B89B-4571-406D-A5DF-A7D318F2F84C}" type="datetimeFigureOut">
              <a:rPr lang="fr-FR" smtClean="0"/>
              <a:t>20/04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77D169D-0BE1-4C33-BEB2-F521420683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53A6650-5DB2-4B56-8931-63DCE3F993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68E97-6E2B-4D8D-A31A-DDE16DAD4F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47595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A480C9B-0DC0-4365-A7C1-5B8AFC33F8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FBA6A53-DEC5-4393-947D-38DCE79E40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6D41FD2-BBDB-4CEC-9EA4-672A2F4233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B89B-4571-406D-A5DF-A7D318F2F84C}" type="datetimeFigureOut">
              <a:rPr lang="fr-FR" smtClean="0"/>
              <a:t>20/04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FD44A56-8D71-494F-938B-60EE1C2CEB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7EAA0FB-9246-47C1-97A1-DEC5DEB5E9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68E97-6E2B-4D8D-A31A-DDE16DAD4F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69333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32BA8D05-2EEB-42B2-8ED6-48F680EC13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68E4E314-4241-4E50-9205-42B99D9492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D359043-F09B-4F1A-9130-6DBA723D67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B89B-4571-406D-A5DF-A7D318F2F84C}" type="datetimeFigureOut">
              <a:rPr lang="fr-FR" smtClean="0"/>
              <a:t>20/04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A8FC557-3E4D-4B34-A521-8FAF50B89C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3B2A1DB-A0B4-4664-B58A-F877439AF5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68E97-6E2B-4D8D-A31A-DDE16DAD4F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09409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44490BB-B357-4FEB-9654-2D31D04CF5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72947AB-3FDD-4C19-9BF3-8A60EA6CAB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110C1EA-4261-4504-9763-BC08C87825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B89B-4571-406D-A5DF-A7D318F2F84C}" type="datetimeFigureOut">
              <a:rPr lang="fr-FR" smtClean="0"/>
              <a:t>20/04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B5CF60E-3A3D-4DA3-8E5C-3882919E4D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75E2D84-53E6-424D-A593-EA14AD9C21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68E97-6E2B-4D8D-A31A-DDE16DAD4F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9883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6FD4D4B-F782-4B7A-912A-1CB6ED2577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E6F8265-D827-480E-AE83-47F24B1173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FF8A401-3489-4E76-A0DB-4CC982085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B89B-4571-406D-A5DF-A7D318F2F84C}" type="datetimeFigureOut">
              <a:rPr lang="fr-FR" smtClean="0"/>
              <a:t>20/04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F14E981-4AA5-41BD-BB69-84291880C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A20CD35-4263-4D0D-9214-03ED431035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68E97-6E2B-4D8D-A31A-DDE16DAD4F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886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EFB58A9-722A-4F72-AAAF-81BE5D06D9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AC8B370-45D0-48CB-BE4C-34313C1F641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9C27F1F-71A6-42B8-8E72-27798772EC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5A506E3-BCB6-4FF2-9EC2-D8FE6BC63D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B89B-4571-406D-A5DF-A7D318F2F84C}" type="datetimeFigureOut">
              <a:rPr lang="fr-FR" smtClean="0"/>
              <a:t>20/04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07DFFFE-852F-4884-A2A9-C537C4BF50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717ECFE-2247-472B-8C29-5E91ABA4A9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68E97-6E2B-4D8D-A31A-DDE16DAD4F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64063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DB3FBBC-2268-4EE0-960C-0D1656D1BC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06F5A4F-E6DD-41AB-ACD8-333503EBA8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E97F8A2-88E5-4A95-8E22-CCF7B05C4D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9389DE4F-03B5-4C8F-A9DB-78BE9CCE67F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E46B4BDB-1ED3-466F-8D44-E92BA5AA954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C3F76B62-AD68-4452-841A-87F08DA5B6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B89B-4571-406D-A5DF-A7D318F2F84C}" type="datetimeFigureOut">
              <a:rPr lang="fr-FR" smtClean="0"/>
              <a:t>20/04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32CBF42A-8589-4D1E-B8A5-4B68092D12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F4B61230-54AA-43D8-BB76-C117A960A9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68E97-6E2B-4D8D-A31A-DDE16DAD4F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440663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BD6312E-AE1E-46E5-9F85-1E1E15D71E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1F77324B-CEE4-4D1A-9FA6-5DE723B430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B89B-4571-406D-A5DF-A7D318F2F84C}" type="datetimeFigureOut">
              <a:rPr lang="fr-FR" smtClean="0"/>
              <a:t>20/04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B50E1A53-39E3-457E-85D9-7A7A6C1BEE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DF98E302-9879-4705-B085-DFE1CB3493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68E97-6E2B-4D8D-A31A-DDE16DAD4F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2829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3FD3853D-7F14-425A-B30E-D8A85E22B6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B89B-4571-406D-A5DF-A7D318F2F84C}" type="datetimeFigureOut">
              <a:rPr lang="fr-FR" smtClean="0"/>
              <a:t>20/04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6715CC71-8791-411A-B7A5-865F8529B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2C82829-7AC9-4FE2-9137-A2AA8588B1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68E97-6E2B-4D8D-A31A-DDE16DAD4F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3336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37019FF-E760-4518-A3E5-220A060B50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C60A459-E011-468C-A05D-DB717559E6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7AE38A5D-C416-428E-9BBC-F21A60CAE8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BE7030A-7846-4C82-BB61-324E90A94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B89B-4571-406D-A5DF-A7D318F2F84C}" type="datetimeFigureOut">
              <a:rPr lang="fr-FR" smtClean="0"/>
              <a:t>20/04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F258A65-5CA9-4D9B-9C75-5D5EF9A953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CB9707B-F3AF-4DA0-AC2B-80144CECA9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68E97-6E2B-4D8D-A31A-DDE16DAD4F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66019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CB96700-4B23-474C-BA71-3D49DFA70D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BC23C8C6-29F0-4B2C-86DE-DDAB236E2B5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A112B67-ADED-4177-944A-43033A8162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7F1E6B6-5A3D-46C7-AED8-2821243859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B89B-4571-406D-A5DF-A7D318F2F84C}" type="datetimeFigureOut">
              <a:rPr lang="fr-FR" smtClean="0"/>
              <a:t>20/04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E2FDBCC-D03C-40E8-9716-73171E3DB7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5A5B084-DE9F-446C-97A2-5C587DBA40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68E97-6E2B-4D8D-A31A-DDE16DAD4F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60713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3061CEF9-CADB-4F05-A277-5325085F61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A21353C-2458-471F-B3FD-E6446450DD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570184-FD99-445C-AEEE-B0472A3ED91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97B89B-4571-406D-A5DF-A7D318F2F84C}" type="datetimeFigureOut">
              <a:rPr lang="fr-FR" smtClean="0"/>
              <a:t>20/04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8B1446E-ADF0-41A4-B731-BADB82CD060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6BDCFAA-48D7-4A03-9592-30E96A315A0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268E97-6E2B-4D8D-A31A-DDE16DAD4F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45673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Relationship Id="rId9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7" Type="http://schemas.openxmlformats.org/officeDocument/2006/relationships/image" Target="../media/image20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4.png"/><Relationship Id="rId4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9F6946A6-F017-4E64-891A-A70976EF4215}"/>
              </a:ext>
            </a:extLst>
          </p:cNvPr>
          <p:cNvSpPr/>
          <p:nvPr/>
        </p:nvSpPr>
        <p:spPr>
          <a:xfrm>
            <a:off x="2738411" y="249342"/>
            <a:ext cx="831390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Multiple genomic alignments using </a:t>
            </a:r>
            <a:r>
              <a:rPr lang="en-US" b="1" u="sng" dirty="0"/>
              <a:t>Ensembl102 with 13 eutherian mammals EPO</a:t>
            </a:r>
            <a:r>
              <a:rPr lang="en-US" dirty="0"/>
              <a:t>:</a:t>
            </a:r>
          </a:p>
          <a:p>
            <a:r>
              <a:rPr lang="en-US" i="1" dirty="0"/>
              <a:t>SLC19A3</a:t>
            </a:r>
            <a:r>
              <a:rPr lang="en-US" dirty="0"/>
              <a:t>: c.74 T&gt;C; p.(Phe25Ser) 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2B7D42F7-BAE7-4DC8-863F-A10FABA9C2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0907" y="3466601"/>
            <a:ext cx="8759892" cy="3401047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89C077FD-38D4-4CD0-A70D-A297D20ECBA1}"/>
              </a:ext>
            </a:extLst>
          </p:cNvPr>
          <p:cNvSpPr/>
          <p:nvPr/>
        </p:nvSpPr>
        <p:spPr>
          <a:xfrm>
            <a:off x="5037331" y="3466601"/>
            <a:ext cx="157521" cy="340104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60BF6295-4D0A-4628-96AE-1DF91C141F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34415" y="886391"/>
            <a:ext cx="3878691" cy="2580209"/>
          </a:xfrm>
          <a:prstGeom prst="rect">
            <a:avLst/>
          </a:prstGeom>
        </p:spPr>
      </p:pic>
      <p:cxnSp>
        <p:nvCxnSpPr>
          <p:cNvPr id="9" name="Connecteur droit avec flèche 8">
            <a:extLst>
              <a:ext uri="{FF2B5EF4-FFF2-40B4-BE49-F238E27FC236}">
                <a16:creationId xmlns:a16="http://schemas.microsoft.com/office/drawing/2014/main" id="{6FA3EF7D-0CDC-44DA-B093-9A900475B8B8}"/>
              </a:ext>
            </a:extLst>
          </p:cNvPr>
          <p:cNvCxnSpPr>
            <a:cxnSpLocks/>
          </p:cNvCxnSpPr>
          <p:nvPr/>
        </p:nvCxnSpPr>
        <p:spPr>
          <a:xfrm>
            <a:off x="5071654" y="1166834"/>
            <a:ext cx="0" cy="57914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183548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B6A99E3C-3A95-4A66-AF9E-13B2A4ACED5B}"/>
              </a:ext>
            </a:extLst>
          </p:cNvPr>
          <p:cNvSpPr/>
          <p:nvPr/>
        </p:nvSpPr>
        <p:spPr>
          <a:xfrm>
            <a:off x="4235907" y="527638"/>
            <a:ext cx="3775264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Multiple Alignments with </a:t>
            </a:r>
            <a:r>
              <a:rPr lang="en-US" b="1" u="sng" dirty="0"/>
              <a:t>UniprotKB</a:t>
            </a:r>
            <a:r>
              <a:rPr lang="en-US" dirty="0"/>
              <a:t>:</a:t>
            </a:r>
          </a:p>
          <a:p>
            <a:r>
              <a:rPr lang="en-US" b="1" i="1" dirty="0">
                <a:solidFill>
                  <a:schemeClr val="accent1"/>
                </a:solidFill>
              </a:rPr>
              <a:t>SLC19A3</a:t>
            </a:r>
            <a:r>
              <a:rPr lang="en-US" b="1" dirty="0">
                <a:solidFill>
                  <a:schemeClr val="accent1"/>
                </a:solidFill>
              </a:rPr>
              <a:t>: c.74 T&gt;C; p.(Phe25Ser) 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B6AD0F8F-32A9-45B3-A780-871CAA76D244}"/>
              </a:ext>
            </a:extLst>
          </p:cNvPr>
          <p:cNvSpPr txBox="1"/>
          <p:nvPr/>
        </p:nvSpPr>
        <p:spPr>
          <a:xfrm>
            <a:off x="2319132" y="1147669"/>
            <a:ext cx="80440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solidFill>
                  <a:schemeClr val="accent1"/>
                </a:solidFill>
              </a:rPr>
              <a:t>The variant is located in the transmembrane helical domain of the thiamine transporter 2 (ThTr-2) which spans from residue 8 to residue 28 (</a:t>
            </a:r>
            <a:r>
              <a:rPr lang="en-US" b="1" dirty="0" err="1">
                <a:solidFill>
                  <a:schemeClr val="accent1"/>
                </a:solidFill>
              </a:rPr>
              <a:t>Uniprot</a:t>
            </a:r>
            <a:r>
              <a:rPr lang="en-US" b="1" dirty="0">
                <a:solidFill>
                  <a:schemeClr val="accent1"/>
                </a:solidFill>
              </a:rPr>
              <a:t>).</a:t>
            </a: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43368AFF-2FB3-425F-BC63-84E28913B5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074" y="1818433"/>
            <a:ext cx="12063642" cy="2581289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66EB0E36-34A8-4958-9889-7FF85582A775}"/>
              </a:ext>
            </a:extLst>
          </p:cNvPr>
          <p:cNvSpPr/>
          <p:nvPr/>
        </p:nvSpPr>
        <p:spPr>
          <a:xfrm>
            <a:off x="8435353" y="1818433"/>
            <a:ext cx="112299" cy="258128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id="{8CA1042E-879D-4BDD-A590-53214CBB06D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1703" y="4325027"/>
            <a:ext cx="1188153" cy="277236"/>
          </a:xfrm>
          <a:prstGeom prst="rect">
            <a:avLst/>
          </a:prstGeom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id="{44062DD8-0376-43FD-89E7-DC544BE9C7F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9324" y="4640939"/>
            <a:ext cx="829618" cy="316044"/>
          </a:xfrm>
          <a:prstGeom prst="rect">
            <a:avLst/>
          </a:prstGeom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F126507D-EDB7-4C37-823E-29E2E80A8C7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0151" y="4962341"/>
            <a:ext cx="1772596" cy="316044"/>
          </a:xfrm>
          <a:prstGeom prst="rect">
            <a:avLst/>
          </a:prstGeom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id="{68D334E6-9743-4BD3-B508-F5E16C7C93D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7921" y="5305920"/>
            <a:ext cx="2197227" cy="253014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9E8525F4-5C09-4980-A151-8EA901E12AE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8367" y="5690375"/>
            <a:ext cx="1748546" cy="296124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id="{00AD4F8D-F9BA-4E0F-9703-88EF81E50C1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8856" y="5996010"/>
            <a:ext cx="1315854" cy="347038"/>
          </a:xfrm>
          <a:prstGeom prst="rect">
            <a:avLst/>
          </a:prstGeom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8FC3E688-6D4C-41EB-8377-330B64533B8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1532" y="6352406"/>
            <a:ext cx="968208" cy="333318"/>
          </a:xfrm>
          <a:prstGeom prst="rect">
            <a:avLst/>
          </a:prstGeom>
        </p:spPr>
      </p:pic>
      <p:sp>
        <p:nvSpPr>
          <p:cNvPr id="18" name="ZoneTexte 17">
            <a:extLst>
              <a:ext uri="{FF2B5EF4-FFF2-40B4-BE49-F238E27FC236}">
                <a16:creationId xmlns:a16="http://schemas.microsoft.com/office/drawing/2014/main" id="{0F4EC30D-18F5-4579-A6CF-C5327CA50C89}"/>
              </a:ext>
            </a:extLst>
          </p:cNvPr>
          <p:cNvSpPr txBox="1"/>
          <p:nvPr/>
        </p:nvSpPr>
        <p:spPr>
          <a:xfrm>
            <a:off x="8363964" y="5124008"/>
            <a:ext cx="3828036" cy="16004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u="sng" dirty="0"/>
              <a:t>Caption:</a:t>
            </a:r>
          </a:p>
          <a:p>
            <a:r>
              <a:rPr lang="en-US" sz="1400" dirty="0"/>
              <a:t>*: Highly conserved residue</a:t>
            </a:r>
          </a:p>
          <a:p>
            <a:r>
              <a:rPr lang="en-US" sz="1400" dirty="0"/>
              <a:t>MACFA: Crab-eating macaque </a:t>
            </a:r>
            <a:r>
              <a:rPr lang="en-US" sz="1400" i="1" dirty="0" err="1"/>
              <a:t>Macaca</a:t>
            </a:r>
            <a:r>
              <a:rPr lang="en-US" sz="1400" i="1" dirty="0"/>
              <a:t> </a:t>
            </a:r>
            <a:r>
              <a:rPr lang="en-US" sz="1400" i="1" dirty="0" err="1"/>
              <a:t>fascicularis</a:t>
            </a:r>
            <a:endParaRPr lang="en-US" sz="1400" i="1" dirty="0"/>
          </a:p>
          <a:p>
            <a:r>
              <a:rPr lang="en-US" sz="1400" dirty="0"/>
              <a:t>XENTR: Western clawed frog </a:t>
            </a:r>
            <a:r>
              <a:rPr lang="en-US" sz="1400" i="1" dirty="0"/>
              <a:t>Xenopus tropicalis</a:t>
            </a:r>
          </a:p>
          <a:p>
            <a:r>
              <a:rPr lang="en-US" sz="1400" dirty="0"/>
              <a:t>DANRE: Zebrafish </a:t>
            </a:r>
            <a:r>
              <a:rPr lang="en-US" sz="1400" i="1" dirty="0"/>
              <a:t>Danio rerio</a:t>
            </a:r>
          </a:p>
          <a:p>
            <a:r>
              <a:rPr lang="en-US" sz="1400" dirty="0"/>
              <a:t>FELCA: cat </a:t>
            </a:r>
            <a:r>
              <a:rPr lang="en-US" sz="1400" i="1" dirty="0" err="1"/>
              <a:t>Felis</a:t>
            </a:r>
            <a:r>
              <a:rPr lang="en-US" sz="1400" i="1" dirty="0"/>
              <a:t> </a:t>
            </a:r>
            <a:r>
              <a:rPr lang="en-US" sz="1400" i="1" dirty="0" err="1"/>
              <a:t>catus</a:t>
            </a:r>
            <a:r>
              <a:rPr lang="en-US" sz="1400" dirty="0"/>
              <a:t> </a:t>
            </a:r>
          </a:p>
          <a:p>
            <a:r>
              <a:rPr lang="en-US" sz="1400" dirty="0"/>
              <a:t>MACMU: Rhesus macaque </a:t>
            </a:r>
            <a:r>
              <a:rPr lang="en-US" sz="1400" i="1" dirty="0" err="1"/>
              <a:t>Macaca</a:t>
            </a:r>
            <a:r>
              <a:rPr lang="en-US" sz="1400" i="1" dirty="0"/>
              <a:t> mulatta</a:t>
            </a:r>
          </a:p>
        </p:txBody>
      </p:sp>
    </p:spTree>
    <p:extLst>
      <p:ext uri="{BB962C8B-B14F-4D97-AF65-F5344CB8AC3E}">
        <p14:creationId xmlns:p14="http://schemas.microsoft.com/office/powerpoint/2010/main" val="37499588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3D142232-8F87-4F2E-8368-82132111B1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763" y="132523"/>
            <a:ext cx="12012474" cy="3578294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4ED98D82-BD9B-4A7C-9BB4-F3C48B0B46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9763" y="3724069"/>
            <a:ext cx="12012474" cy="1417776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A8388A4D-91B8-4214-8529-84980621087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6394" y="5214524"/>
            <a:ext cx="10788599" cy="1417776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4BB68268-6A26-462E-90A0-5A43E3AC719F}"/>
              </a:ext>
            </a:extLst>
          </p:cNvPr>
          <p:cNvSpPr/>
          <p:nvPr/>
        </p:nvSpPr>
        <p:spPr>
          <a:xfrm>
            <a:off x="4992019" y="5791200"/>
            <a:ext cx="136572" cy="59428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5EFD9C1B-2C5A-41B2-8B37-B546852E64F1}"/>
              </a:ext>
            </a:extLst>
          </p:cNvPr>
          <p:cNvSpPr txBox="1"/>
          <p:nvPr/>
        </p:nvSpPr>
        <p:spPr>
          <a:xfrm>
            <a:off x="503582" y="6437100"/>
            <a:ext cx="11424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The residue Phe25 is included in the conserved domain. Phe25 is marked in red which refers to a highly conserved aa. 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E42B4024-CA99-4772-806A-2C4B602132C3}"/>
              </a:ext>
            </a:extLst>
          </p:cNvPr>
          <p:cNvSpPr txBox="1"/>
          <p:nvPr/>
        </p:nvSpPr>
        <p:spPr>
          <a:xfrm>
            <a:off x="4344569" y="73096"/>
            <a:ext cx="42900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Conserved domains according to </a:t>
            </a:r>
            <a:r>
              <a:rPr lang="en-US" b="1" u="sng" dirty="0">
                <a:solidFill>
                  <a:srgbClr val="FF0000"/>
                </a:solidFill>
              </a:rPr>
              <a:t>CDD-NCBI</a:t>
            </a:r>
          </a:p>
        </p:txBody>
      </p:sp>
    </p:spTree>
    <p:extLst>
      <p:ext uri="{BB962C8B-B14F-4D97-AF65-F5344CB8AC3E}">
        <p14:creationId xmlns:p14="http://schemas.microsoft.com/office/powerpoint/2010/main" val="2036982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BE6F5FFD-A98B-4E9D-9857-3D314EE3663B}"/>
              </a:ext>
            </a:extLst>
          </p:cNvPr>
          <p:cNvSpPr/>
          <p:nvPr/>
        </p:nvSpPr>
        <p:spPr>
          <a:xfrm>
            <a:off x="2093843" y="97591"/>
            <a:ext cx="852114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Multiple genomic alignments using </a:t>
            </a:r>
            <a:r>
              <a:rPr lang="en-US" b="1" u="sng" dirty="0" err="1"/>
              <a:t>Ensembl</a:t>
            </a:r>
            <a:r>
              <a:rPr lang="en-US" b="1" u="sng" dirty="0"/>
              <a:t> with 15 eutherian mammals EPO</a:t>
            </a:r>
            <a:r>
              <a:rPr lang="en-US" dirty="0"/>
              <a:t>:</a:t>
            </a:r>
          </a:p>
          <a:p>
            <a:r>
              <a:rPr lang="en-GB" b="1" i="1" dirty="0"/>
              <a:t>GHR</a:t>
            </a:r>
            <a:r>
              <a:rPr lang="en-GB" dirty="0"/>
              <a:t> (EX 5): c.329A&gt;G; p.(Asn110Ser)</a:t>
            </a:r>
            <a:endParaRPr lang="en-US" dirty="0"/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E50F023B-7496-4483-B603-1A08BEA2FF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99670" y="3214424"/>
            <a:ext cx="6443041" cy="3636172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ABA40FAA-2C67-4E05-B998-58D40018ED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24721" y="3293201"/>
            <a:ext cx="1538040" cy="3573224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6473DC4A-B09D-41EC-8F84-DA2B6D9111D1}"/>
              </a:ext>
            </a:extLst>
          </p:cNvPr>
          <p:cNvSpPr/>
          <p:nvPr/>
        </p:nvSpPr>
        <p:spPr>
          <a:xfrm>
            <a:off x="6773365" y="3214424"/>
            <a:ext cx="210530" cy="363617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pic>
        <p:nvPicPr>
          <p:cNvPr id="8" name="Image 7">
            <a:extLst>
              <a:ext uri="{FF2B5EF4-FFF2-40B4-BE49-F238E27FC236}">
                <a16:creationId xmlns:a16="http://schemas.microsoft.com/office/drawing/2014/main" id="{ED53EE21-D48D-4B46-942B-76A074B4D0A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33345" y="1000420"/>
            <a:ext cx="3667125" cy="2214004"/>
          </a:xfrm>
          <a:prstGeom prst="rect">
            <a:avLst/>
          </a:prstGeom>
        </p:spPr>
      </p:pic>
      <p:cxnSp>
        <p:nvCxnSpPr>
          <p:cNvPr id="9" name="Connecteur droit avec flèche 8">
            <a:extLst>
              <a:ext uri="{FF2B5EF4-FFF2-40B4-BE49-F238E27FC236}">
                <a16:creationId xmlns:a16="http://schemas.microsoft.com/office/drawing/2014/main" id="{25A284DC-BFA6-48A2-8ECD-03E5117EF2FD}"/>
              </a:ext>
            </a:extLst>
          </p:cNvPr>
          <p:cNvCxnSpPr>
            <a:cxnSpLocks/>
          </p:cNvCxnSpPr>
          <p:nvPr/>
        </p:nvCxnSpPr>
        <p:spPr>
          <a:xfrm>
            <a:off x="6820190" y="1410154"/>
            <a:ext cx="0" cy="57914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309749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B1FE0A41-E34A-45EA-A6F4-1C849A0478AA}"/>
              </a:ext>
            </a:extLst>
          </p:cNvPr>
          <p:cNvSpPr/>
          <p:nvPr/>
        </p:nvSpPr>
        <p:spPr>
          <a:xfrm>
            <a:off x="4358729" y="1279792"/>
            <a:ext cx="37223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dirty="0"/>
              <a:t>Multiple </a:t>
            </a:r>
            <a:r>
              <a:rPr lang="fr-FR" b="1" dirty="0" err="1"/>
              <a:t>Alignments</a:t>
            </a:r>
            <a:r>
              <a:rPr lang="fr-FR" b="1" dirty="0"/>
              <a:t> </a:t>
            </a:r>
            <a:r>
              <a:rPr lang="fr-FR" b="1" dirty="0" err="1"/>
              <a:t>with</a:t>
            </a:r>
            <a:r>
              <a:rPr lang="fr-FR" b="1" dirty="0"/>
              <a:t> </a:t>
            </a:r>
            <a:r>
              <a:rPr lang="fr-FR" b="1" dirty="0" err="1"/>
              <a:t>UniprotKB</a:t>
            </a:r>
            <a:endParaRPr lang="fr-FR" dirty="0"/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732CBF1E-8B1C-478C-8B09-929989F357E7}"/>
              </a:ext>
            </a:extLst>
          </p:cNvPr>
          <p:cNvSpPr txBox="1"/>
          <p:nvPr/>
        </p:nvSpPr>
        <p:spPr>
          <a:xfrm>
            <a:off x="1523182" y="488875"/>
            <a:ext cx="93934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accent1"/>
                </a:solidFill>
              </a:rPr>
              <a:t>The residue Asn110 takes part of the beta strand of the extracellular domain (TOPO_DOM 19-264) of the Growth hormone receptor (GH receptor or Somatotropin receptor GHBP) (</a:t>
            </a:r>
            <a:r>
              <a:rPr lang="en-US" b="1" dirty="0" err="1">
                <a:solidFill>
                  <a:schemeClr val="accent1"/>
                </a:solidFill>
              </a:rPr>
              <a:t>Uniprot</a:t>
            </a:r>
            <a:r>
              <a:rPr lang="en-US" b="1" dirty="0">
                <a:solidFill>
                  <a:schemeClr val="accent1"/>
                </a:solidFill>
              </a:rPr>
              <a:t>).  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7492627-AC3F-4679-AFF7-CDD8EB962B8A}"/>
              </a:ext>
            </a:extLst>
          </p:cNvPr>
          <p:cNvSpPr/>
          <p:nvPr/>
        </p:nvSpPr>
        <p:spPr>
          <a:xfrm>
            <a:off x="4149948" y="100734"/>
            <a:ext cx="36535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i="1" dirty="0">
                <a:solidFill>
                  <a:schemeClr val="accent1"/>
                </a:solidFill>
              </a:rPr>
              <a:t>GHR</a:t>
            </a:r>
            <a:r>
              <a:rPr lang="en-GB" dirty="0">
                <a:solidFill>
                  <a:schemeClr val="accent1"/>
                </a:solidFill>
              </a:rPr>
              <a:t> (EX 5): c.329A&gt;G; p.(Asn110Ser)</a:t>
            </a:r>
            <a:endParaRPr lang="en-US" dirty="0">
              <a:solidFill>
                <a:schemeClr val="accent1"/>
              </a:solidFill>
            </a:endParaRPr>
          </a:p>
        </p:txBody>
      </p:sp>
      <p:pic>
        <p:nvPicPr>
          <p:cNvPr id="12" name="Image 11">
            <a:extLst>
              <a:ext uri="{FF2B5EF4-FFF2-40B4-BE49-F238E27FC236}">
                <a16:creationId xmlns:a16="http://schemas.microsoft.com/office/drawing/2014/main" id="{2064DF27-CB85-45EC-82AD-3F4E3DCF05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095" y="2090690"/>
            <a:ext cx="11868139" cy="2654749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4A9C9A2C-A991-4C04-8E44-5ED46A3A7752}"/>
              </a:ext>
            </a:extLst>
          </p:cNvPr>
          <p:cNvSpPr/>
          <p:nvPr/>
        </p:nvSpPr>
        <p:spPr>
          <a:xfrm>
            <a:off x="10669502" y="2217562"/>
            <a:ext cx="117768" cy="248695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pic>
        <p:nvPicPr>
          <p:cNvPr id="14" name="Image 13">
            <a:extLst>
              <a:ext uri="{FF2B5EF4-FFF2-40B4-BE49-F238E27FC236}">
                <a16:creationId xmlns:a16="http://schemas.microsoft.com/office/drawing/2014/main" id="{AF704962-8311-4DDC-9CBC-4C9419DC82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0085" y="5113263"/>
            <a:ext cx="1210061" cy="320739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433BAC22-FC80-456F-8288-AAD9AA8FC13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6590" y="5362570"/>
            <a:ext cx="2259751" cy="335318"/>
          </a:xfrm>
          <a:prstGeom prst="rect">
            <a:avLst/>
          </a:prstGeom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A578BB46-0458-49F8-A017-DFEC8A4DF6D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2406" y="4762420"/>
            <a:ext cx="1197740" cy="279473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AA3E8131-1489-4A89-BB09-E5C219861A7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6795" y="5714869"/>
            <a:ext cx="2053396" cy="236451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6070F9D7-8D6C-43BD-AF1C-AB4825419F3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7832" y="5992717"/>
            <a:ext cx="1015438" cy="734572"/>
          </a:xfrm>
          <a:prstGeom prst="rect">
            <a:avLst/>
          </a:prstGeom>
        </p:spPr>
      </p:pic>
      <p:sp>
        <p:nvSpPr>
          <p:cNvPr id="20" name="ZoneTexte 19">
            <a:extLst>
              <a:ext uri="{FF2B5EF4-FFF2-40B4-BE49-F238E27FC236}">
                <a16:creationId xmlns:a16="http://schemas.microsoft.com/office/drawing/2014/main" id="{A793514E-7915-4E05-880A-5CACB7B4860A}"/>
              </a:ext>
            </a:extLst>
          </p:cNvPr>
          <p:cNvSpPr txBox="1"/>
          <p:nvPr/>
        </p:nvSpPr>
        <p:spPr>
          <a:xfrm>
            <a:off x="7184795" y="5445361"/>
            <a:ext cx="5007205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u="sng" dirty="0"/>
              <a:t>Caption:</a:t>
            </a:r>
          </a:p>
          <a:p>
            <a:r>
              <a:rPr lang="en-US" sz="1400" dirty="0"/>
              <a:t>BOVIN: Cattle </a:t>
            </a:r>
            <a:r>
              <a:rPr lang="en-US" sz="1400" i="1" dirty="0"/>
              <a:t>Bos </a:t>
            </a:r>
            <a:r>
              <a:rPr lang="en-US" sz="1400" i="1" dirty="0" err="1"/>
              <a:t>taurus</a:t>
            </a:r>
            <a:endParaRPr lang="en-US" sz="1400" i="1" dirty="0"/>
          </a:p>
          <a:p>
            <a:r>
              <a:rPr lang="en-US" sz="1400" dirty="0"/>
              <a:t>CHICK: Red junglefowl </a:t>
            </a:r>
            <a:r>
              <a:rPr lang="en-US" sz="1400" i="1" dirty="0"/>
              <a:t>Gallus </a:t>
            </a:r>
            <a:r>
              <a:rPr lang="en-US" sz="1400" i="1" dirty="0" err="1"/>
              <a:t>gallus</a:t>
            </a:r>
            <a:endParaRPr lang="en-US" sz="1400" i="1" dirty="0"/>
          </a:p>
          <a:p>
            <a:r>
              <a:rPr lang="en-US" sz="1400" dirty="0"/>
              <a:t>CANLF: Dog </a:t>
            </a:r>
            <a:r>
              <a:rPr lang="en-US" sz="1400" i="1" dirty="0" err="1"/>
              <a:t>Canis</a:t>
            </a:r>
            <a:r>
              <a:rPr lang="en-US" sz="1400" i="1" dirty="0"/>
              <a:t> lupus </a:t>
            </a:r>
            <a:r>
              <a:rPr lang="en-US" sz="1400" i="1" dirty="0" err="1"/>
              <a:t>familiaris</a:t>
            </a:r>
            <a:endParaRPr lang="en-US" sz="1400" i="1" dirty="0"/>
          </a:p>
          <a:p>
            <a:r>
              <a:rPr lang="en-US" sz="1400" dirty="0"/>
              <a:t>PAPAN: Olive baboon </a:t>
            </a:r>
            <a:r>
              <a:rPr lang="en-US" sz="1400" i="1" dirty="0" err="1"/>
              <a:t>Papio</a:t>
            </a:r>
            <a:r>
              <a:rPr lang="en-US" sz="1400" i="1" dirty="0"/>
              <a:t> </a:t>
            </a:r>
            <a:r>
              <a:rPr lang="en-US" sz="1400" i="1" dirty="0" err="1"/>
              <a:t>anubis</a:t>
            </a:r>
            <a:endParaRPr lang="en-US" sz="1400" i="1" dirty="0"/>
          </a:p>
          <a:p>
            <a:r>
              <a:rPr lang="en-US" sz="1400" dirty="0"/>
              <a:t>SAIBB: Black-capped squirrel monkey </a:t>
            </a:r>
            <a:r>
              <a:rPr lang="en-US" sz="1400" i="1" dirty="0"/>
              <a:t>Saimiri </a:t>
            </a:r>
            <a:r>
              <a:rPr lang="en-US" sz="1400" i="1" dirty="0" err="1"/>
              <a:t>boliviensis</a:t>
            </a:r>
            <a:r>
              <a:rPr lang="en-US" sz="1400" i="1" dirty="0"/>
              <a:t> </a:t>
            </a:r>
            <a:r>
              <a:rPr lang="en-US" sz="1400" i="1" dirty="0" err="1"/>
              <a:t>boliviensis</a:t>
            </a:r>
            <a:endParaRPr lang="en-US" sz="1400" i="1" dirty="0"/>
          </a:p>
        </p:txBody>
      </p:sp>
    </p:spTree>
    <p:extLst>
      <p:ext uri="{BB962C8B-B14F-4D97-AF65-F5344CB8AC3E}">
        <p14:creationId xmlns:p14="http://schemas.microsoft.com/office/powerpoint/2010/main" val="2092911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B4FE924F-E5D5-4C06-A1A3-518441DFF06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8944" y="36444"/>
            <a:ext cx="9180029" cy="3288817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1E97CD85-553E-4D96-BF99-B5730D4E0CE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9565"/>
          <a:stretch/>
        </p:blipFill>
        <p:spPr>
          <a:xfrm>
            <a:off x="2561395" y="3325260"/>
            <a:ext cx="6715125" cy="1233488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80BED941-DBA7-4044-B9F3-9D5462285397}"/>
              </a:ext>
            </a:extLst>
          </p:cNvPr>
          <p:cNvSpPr txBox="1"/>
          <p:nvPr/>
        </p:nvSpPr>
        <p:spPr>
          <a:xfrm>
            <a:off x="0" y="3750488"/>
            <a:ext cx="3110536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err="1"/>
              <a:t>Pfam</a:t>
            </a:r>
            <a:r>
              <a:rPr lang="fr-FR" sz="1200" dirty="0"/>
              <a:t> 09067: The </a:t>
            </a:r>
            <a:r>
              <a:rPr lang="fr-FR" sz="1200" dirty="0" err="1"/>
              <a:t>residue</a:t>
            </a:r>
            <a:r>
              <a:rPr lang="fr-FR" sz="1200" dirty="0"/>
              <a:t> Asn110 </a:t>
            </a:r>
            <a:r>
              <a:rPr lang="fr-FR" sz="1200" dirty="0" err="1"/>
              <a:t>is</a:t>
            </a:r>
            <a:r>
              <a:rPr lang="fr-FR" sz="1200" dirty="0"/>
              <a:t> not </a:t>
            </a:r>
            <a:r>
              <a:rPr lang="fr-FR" sz="1200" dirty="0" err="1"/>
              <a:t>included</a:t>
            </a:r>
            <a:r>
              <a:rPr lang="fr-FR" sz="1200" dirty="0"/>
              <a:t> in the </a:t>
            </a:r>
            <a:r>
              <a:rPr lang="fr-FR" sz="1200" dirty="0" err="1"/>
              <a:t>conserved</a:t>
            </a:r>
            <a:r>
              <a:rPr lang="fr-FR" sz="1200" dirty="0"/>
              <a:t> </a:t>
            </a:r>
            <a:r>
              <a:rPr lang="fr-FR" sz="1200" dirty="0" err="1"/>
              <a:t>domain</a:t>
            </a:r>
            <a:r>
              <a:rPr lang="fr-FR" sz="1200" dirty="0"/>
              <a:t> </a:t>
            </a:r>
            <a:r>
              <a:rPr lang="fr-FR" sz="1200" dirty="0" err="1"/>
              <a:t>according</a:t>
            </a:r>
            <a:r>
              <a:rPr lang="fr-FR" sz="1200" dirty="0"/>
              <a:t> to CDD </a:t>
            </a:r>
            <a:r>
              <a:rPr lang="fr-FR" sz="1200" dirty="0" err="1"/>
              <a:t>database</a:t>
            </a:r>
            <a:r>
              <a:rPr lang="fr-FR" sz="1200" dirty="0"/>
              <a:t>. </a:t>
            </a:r>
            <a:r>
              <a:rPr lang="en-US" sz="1200" dirty="0"/>
              <a:t>[Non-specific hit, </a:t>
            </a:r>
            <a:r>
              <a:rPr lang="en-US" sz="1200" dirty="0" err="1"/>
              <a:t>evalue</a:t>
            </a:r>
            <a:r>
              <a:rPr lang="en-US" sz="1200" dirty="0"/>
              <a:t> = 2.32e-13]pfam09067, Erythropoietin receptor, ligand binding ;Members of this family interact with erythropoietin (EPO), with subsequent initiation of the downstream chain of events associated with binding of EPO to the receptor, including EPO-induced erythroblast proliferation and differentiation through induction of the JAK2/STAT5 signaling cascade. The domain adopts a secondary structure composed of a short amino-terminal helix, followed by two beta-sandwich regions.</a:t>
            </a:r>
            <a:endParaRPr lang="fr-FR" sz="1200" dirty="0"/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1502010D-BB6E-42E3-B0B4-A0F3F9BB1AB5}"/>
              </a:ext>
            </a:extLst>
          </p:cNvPr>
          <p:cNvSpPr txBox="1"/>
          <p:nvPr/>
        </p:nvSpPr>
        <p:spPr>
          <a:xfrm>
            <a:off x="9276520" y="3409986"/>
            <a:ext cx="2915480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/>
              <a:t>This residue belongs to the  </a:t>
            </a:r>
            <a:r>
              <a:rPr lang="fr-FR" sz="1400" u="sng" dirty="0" err="1"/>
              <a:t>Erythropoietin</a:t>
            </a:r>
            <a:r>
              <a:rPr lang="fr-FR" sz="1400" u="sng" dirty="0"/>
              <a:t> </a:t>
            </a:r>
            <a:r>
              <a:rPr lang="fr-FR" sz="1400" u="sng" dirty="0" err="1"/>
              <a:t>receptor</a:t>
            </a:r>
            <a:r>
              <a:rPr lang="fr-FR" sz="1400" u="sng" dirty="0"/>
              <a:t>, ligand binding </a:t>
            </a:r>
            <a:r>
              <a:rPr lang="fr-FR" sz="1400" u="sng" dirty="0" err="1"/>
              <a:t>domain</a:t>
            </a:r>
            <a:r>
              <a:rPr lang="fr-FR" sz="1400" dirty="0"/>
              <a:t> (</a:t>
            </a:r>
            <a:r>
              <a:rPr lang="fr-FR" sz="1400" dirty="0" err="1"/>
              <a:t>pfam</a:t>
            </a:r>
            <a:r>
              <a:rPr lang="fr-FR" sz="1400" dirty="0"/>
              <a:t>).</a:t>
            </a:r>
          </a:p>
          <a:p>
            <a:pPr algn="just"/>
            <a:r>
              <a:rPr lang="fr-FR" sz="1400" b="1" dirty="0">
                <a:solidFill>
                  <a:srgbClr val="FF0000"/>
                </a:solidFill>
              </a:rPr>
              <a:t>Asn110 </a:t>
            </a:r>
            <a:r>
              <a:rPr lang="en-US" sz="1400" b="1" dirty="0">
                <a:solidFill>
                  <a:srgbClr val="FF0000"/>
                </a:solidFill>
              </a:rPr>
              <a:t>is marked in red which refers to a highly conserved aa. </a:t>
            </a:r>
            <a:endParaRPr lang="fr-FR" sz="1400" b="1" dirty="0">
              <a:solidFill>
                <a:srgbClr val="FF0000"/>
              </a:solidFill>
            </a:endParaRPr>
          </a:p>
          <a:p>
            <a:pPr algn="just"/>
            <a:endParaRPr lang="en-US" sz="1400" dirty="0">
              <a:solidFill>
                <a:srgbClr val="FF0000"/>
              </a:solidFill>
            </a:endParaRPr>
          </a:p>
          <a:p>
            <a:pPr algn="just"/>
            <a:r>
              <a:rPr lang="en-US" sz="1400" dirty="0">
                <a:solidFill>
                  <a:srgbClr val="FF0000"/>
                </a:solidFill>
              </a:rPr>
              <a:t> 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97AC45D5-20DC-4301-A2EF-0DB7FE1067EE}"/>
              </a:ext>
            </a:extLst>
          </p:cNvPr>
          <p:cNvSpPr/>
          <p:nvPr/>
        </p:nvSpPr>
        <p:spPr>
          <a:xfrm>
            <a:off x="7515486" y="3442375"/>
            <a:ext cx="157522" cy="21774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97A355CE-2323-4787-8C2B-C3ABF29AE3A9}"/>
              </a:ext>
            </a:extLst>
          </p:cNvPr>
          <p:cNvSpPr txBox="1"/>
          <p:nvPr/>
        </p:nvSpPr>
        <p:spPr>
          <a:xfrm>
            <a:off x="5019455" y="3952181"/>
            <a:ext cx="21771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onserved domain: 49-127</a:t>
            </a:r>
          </a:p>
        </p:txBody>
      </p:sp>
      <p:pic>
        <p:nvPicPr>
          <p:cNvPr id="15" name="Image 14">
            <a:extLst>
              <a:ext uri="{FF2B5EF4-FFF2-40B4-BE49-F238E27FC236}">
                <a16:creationId xmlns:a16="http://schemas.microsoft.com/office/drawing/2014/main" id="{5CC98FC6-C0D4-4714-8B35-28F572C541F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52789" y="4703206"/>
            <a:ext cx="8525393" cy="2056019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0FC98800-EEE8-4143-BF07-8F1980F17101}"/>
              </a:ext>
            </a:extLst>
          </p:cNvPr>
          <p:cNvSpPr/>
          <p:nvPr/>
        </p:nvSpPr>
        <p:spPr>
          <a:xfrm>
            <a:off x="8569034" y="5670105"/>
            <a:ext cx="97888" cy="33313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5731512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9</TotalTime>
  <Words>375</Words>
  <Application>Microsoft Office PowerPoint</Application>
  <PresentationFormat>Grand écran</PresentationFormat>
  <Paragraphs>31</Paragraphs>
  <Slides>6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noureddine</dc:creator>
  <cp:lastModifiedBy>noureddine</cp:lastModifiedBy>
  <cp:revision>33</cp:revision>
  <dcterms:created xsi:type="dcterms:W3CDTF">2021-01-15T20:28:53Z</dcterms:created>
  <dcterms:modified xsi:type="dcterms:W3CDTF">2021-04-20T20:36:18Z</dcterms:modified>
</cp:coreProperties>
</file>